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3" r:id="rId2"/>
  </p:sldIdLst>
  <p:sldSz cx="12192000" cy="6858000"/>
  <p:notesSz cx="6794500" cy="9906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7025" autoAdjust="0"/>
    <p:restoredTop sz="94660"/>
  </p:normalViewPr>
  <p:slideViewPr>
    <p:cSldViewPr snapToGrid="0">
      <p:cViewPr varScale="1">
        <p:scale>
          <a:sx n="105" d="100"/>
          <a:sy n="105" d="100"/>
        </p:scale>
        <p:origin x="120" y="22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5CAC70C6-296C-4BC3-9553-5DC062FE54C6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Sous-titre 2">
            <a:extLst>
              <a:ext uri="{FF2B5EF4-FFF2-40B4-BE49-F238E27FC236}">
                <a16:creationId xmlns:a16="http://schemas.microsoft.com/office/drawing/2014/main" id="{2E8F6527-F64E-405C-B346-FFA3886F3454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fr-FR"/>
              <a:t>Modifiez le style des sous-titres du masque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47250D2F-DAAB-4A7F-BBBF-D4831E88BEA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9AC13D-D462-455C-A8A4-B01D924C7252}" type="datetimeFigureOut">
              <a:rPr lang="fr-FR" smtClean="0"/>
              <a:t>18/05/2019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06F69D2D-D768-4BBE-818A-15135C38D57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A1328E23-9F47-4860-8CB0-0A19C35D7F3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79FB26-0C37-4F20-B484-D4D7BE0B9AA8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31339668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9CB2D9A6-21F8-4081-B5BB-239937529F9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vertical 2">
            <a:extLst>
              <a:ext uri="{FF2B5EF4-FFF2-40B4-BE49-F238E27FC236}">
                <a16:creationId xmlns:a16="http://schemas.microsoft.com/office/drawing/2014/main" id="{64EA46AC-5CAE-4BA8-B232-6F8DD6AF38B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BE0821EF-AA0B-4922-A070-8385D44BFA6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9AC13D-D462-455C-A8A4-B01D924C7252}" type="datetimeFigureOut">
              <a:rPr lang="fr-FR" smtClean="0"/>
              <a:t>18/05/2019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77ABCCD8-D7E4-4819-8297-61A66ABB169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E461F2BD-B995-4D97-8F6E-8156E8FEEC8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79FB26-0C37-4F20-B484-D4D7BE0B9AA8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23155701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>
            <a:extLst>
              <a:ext uri="{FF2B5EF4-FFF2-40B4-BE49-F238E27FC236}">
                <a16:creationId xmlns:a16="http://schemas.microsoft.com/office/drawing/2014/main" id="{8740BED5-F78A-4E22-9463-6FE5E1B468A9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vertical 2">
            <a:extLst>
              <a:ext uri="{FF2B5EF4-FFF2-40B4-BE49-F238E27FC236}">
                <a16:creationId xmlns:a16="http://schemas.microsoft.com/office/drawing/2014/main" id="{845DDE23-D5A5-4380-89F6-9DC37740549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A6A193ED-D9F5-41C4-B0C1-CF09B613001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9AC13D-D462-455C-A8A4-B01D924C7252}" type="datetimeFigureOut">
              <a:rPr lang="fr-FR" smtClean="0"/>
              <a:t>18/05/2019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70F41D42-8761-473A-B335-D84FFB0DA8E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E2FC502E-D173-4BDB-B5A5-49F9F6F8A31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79FB26-0C37-4F20-B484-D4D7BE0B9AA8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40866572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6EC75A54-5914-4151-9295-87CC1ADE82E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D316821F-D95D-4D74-957B-5FF2D8160A99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08F7EFF6-E037-431E-94F9-3E062E6CB75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9AC13D-D462-455C-A8A4-B01D924C7252}" type="datetimeFigureOut">
              <a:rPr lang="fr-FR" smtClean="0"/>
              <a:t>18/05/2019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B977FF36-1371-4839-8074-0A98C829BBE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754CF7C7-F2D6-4CDA-91FE-30432782649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79FB26-0C37-4F20-B484-D4D7BE0B9AA8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56952239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E3742682-15E7-4EC6-93C3-8A550A8F816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5F306F83-CF94-4AF6-895E-CB53579D018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F1822BEC-5F89-45AB-AF8F-CA27C993BF5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9AC13D-D462-455C-A8A4-B01D924C7252}" type="datetimeFigureOut">
              <a:rPr lang="fr-FR" smtClean="0"/>
              <a:t>18/05/2019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FFFF2B30-B699-4FC0-8331-96E363BB887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E7B15E90-E3EF-48C6-8D73-F61B6E5F290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79FB26-0C37-4F20-B484-D4D7BE0B9AA8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18553216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414C86D3-D813-44C4-9A18-798DFB9C0C4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C2CEB917-0132-45CC-92D8-F39D82D6777F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u contenu 3">
            <a:extLst>
              <a:ext uri="{FF2B5EF4-FFF2-40B4-BE49-F238E27FC236}">
                <a16:creationId xmlns:a16="http://schemas.microsoft.com/office/drawing/2014/main" id="{7C73C1BE-744B-4F1D-825E-DA1037CC62E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C6D0656F-03A1-4875-98B8-6615A9CE5AA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9AC13D-D462-455C-A8A4-B01D924C7252}" type="datetimeFigureOut">
              <a:rPr lang="fr-FR" smtClean="0"/>
              <a:t>18/05/2019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17A46E19-0B76-4024-BEE7-0E4A25E51AF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9C315A57-8ECC-46A7-8082-D7810300625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79FB26-0C37-4F20-B484-D4D7BE0B9AA8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49637008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65E21CD1-3A5B-456B-8433-14875D78FE1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ED037752-2CC7-4B04-A2F4-E3F14276E53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4" name="Espace réservé du contenu 3">
            <a:extLst>
              <a:ext uri="{FF2B5EF4-FFF2-40B4-BE49-F238E27FC236}">
                <a16:creationId xmlns:a16="http://schemas.microsoft.com/office/drawing/2014/main" id="{37BB09F3-5608-47FD-9CF7-73ECE8CBA80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5" name="Espace réservé du texte 4">
            <a:extLst>
              <a:ext uri="{FF2B5EF4-FFF2-40B4-BE49-F238E27FC236}">
                <a16:creationId xmlns:a16="http://schemas.microsoft.com/office/drawing/2014/main" id="{96A7B4BF-67B2-403B-80CD-AB07E4290B98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6" name="Espace réservé du contenu 5">
            <a:extLst>
              <a:ext uri="{FF2B5EF4-FFF2-40B4-BE49-F238E27FC236}">
                <a16:creationId xmlns:a16="http://schemas.microsoft.com/office/drawing/2014/main" id="{12C78B5D-8B55-4692-ABE9-44172807933A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7" name="Espace réservé de la date 6">
            <a:extLst>
              <a:ext uri="{FF2B5EF4-FFF2-40B4-BE49-F238E27FC236}">
                <a16:creationId xmlns:a16="http://schemas.microsoft.com/office/drawing/2014/main" id="{DA509E1B-950B-496F-A0FD-933916E62D6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9AC13D-D462-455C-A8A4-B01D924C7252}" type="datetimeFigureOut">
              <a:rPr lang="fr-FR" smtClean="0"/>
              <a:t>18/05/2019</a:t>
            </a:fld>
            <a:endParaRPr lang="fr-FR"/>
          </a:p>
        </p:txBody>
      </p:sp>
      <p:sp>
        <p:nvSpPr>
          <p:cNvPr id="8" name="Espace réservé du pied de page 7">
            <a:extLst>
              <a:ext uri="{FF2B5EF4-FFF2-40B4-BE49-F238E27FC236}">
                <a16:creationId xmlns:a16="http://schemas.microsoft.com/office/drawing/2014/main" id="{5AF6BF43-BEB0-4026-9683-49581A90881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>
            <a:extLst>
              <a:ext uri="{FF2B5EF4-FFF2-40B4-BE49-F238E27FC236}">
                <a16:creationId xmlns:a16="http://schemas.microsoft.com/office/drawing/2014/main" id="{0CFF9179-0697-4BA9-B5CB-6088D0795CB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79FB26-0C37-4F20-B484-D4D7BE0B9AA8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27596283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563A1C34-1A26-453A-81C4-7142B4F2380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e la date 2">
            <a:extLst>
              <a:ext uri="{FF2B5EF4-FFF2-40B4-BE49-F238E27FC236}">
                <a16:creationId xmlns:a16="http://schemas.microsoft.com/office/drawing/2014/main" id="{F0BE8EC2-9D8B-43B0-AFCC-02805F4C261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9AC13D-D462-455C-A8A4-B01D924C7252}" type="datetimeFigureOut">
              <a:rPr lang="fr-FR" smtClean="0"/>
              <a:t>18/05/2019</a:t>
            </a:fld>
            <a:endParaRPr lang="fr-FR"/>
          </a:p>
        </p:txBody>
      </p:sp>
      <p:sp>
        <p:nvSpPr>
          <p:cNvPr id="4" name="Espace réservé du pied de page 3">
            <a:extLst>
              <a:ext uri="{FF2B5EF4-FFF2-40B4-BE49-F238E27FC236}">
                <a16:creationId xmlns:a16="http://schemas.microsoft.com/office/drawing/2014/main" id="{EA12BCAC-0700-4C7B-A239-AB7C82E0129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>
            <a:extLst>
              <a:ext uri="{FF2B5EF4-FFF2-40B4-BE49-F238E27FC236}">
                <a16:creationId xmlns:a16="http://schemas.microsoft.com/office/drawing/2014/main" id="{46440BDE-51C8-41C5-9183-836B6824E03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79FB26-0C37-4F20-B484-D4D7BE0B9AA8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52754916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>
            <a:extLst>
              <a:ext uri="{FF2B5EF4-FFF2-40B4-BE49-F238E27FC236}">
                <a16:creationId xmlns:a16="http://schemas.microsoft.com/office/drawing/2014/main" id="{5F1978B6-7448-494F-B6D9-CAB62DE0E87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9AC13D-D462-455C-A8A4-B01D924C7252}" type="datetimeFigureOut">
              <a:rPr lang="fr-FR" smtClean="0"/>
              <a:t>18/05/2019</a:t>
            </a:fld>
            <a:endParaRPr lang="fr-FR"/>
          </a:p>
        </p:txBody>
      </p:sp>
      <p:sp>
        <p:nvSpPr>
          <p:cNvPr id="3" name="Espace réservé du pied de page 2">
            <a:extLst>
              <a:ext uri="{FF2B5EF4-FFF2-40B4-BE49-F238E27FC236}">
                <a16:creationId xmlns:a16="http://schemas.microsoft.com/office/drawing/2014/main" id="{09212692-6BB5-46A0-A831-F953F556AB3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>
            <a:extLst>
              <a:ext uri="{FF2B5EF4-FFF2-40B4-BE49-F238E27FC236}">
                <a16:creationId xmlns:a16="http://schemas.microsoft.com/office/drawing/2014/main" id="{0E970B90-FEC2-4B19-BD16-14B08C0D6A9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79FB26-0C37-4F20-B484-D4D7BE0B9AA8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0528619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72E4B824-8180-45E6-A580-72A7819BD38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F715DE85-AE1E-4A58-8CF8-407A5607D691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u texte 3">
            <a:extLst>
              <a:ext uri="{FF2B5EF4-FFF2-40B4-BE49-F238E27FC236}">
                <a16:creationId xmlns:a16="http://schemas.microsoft.com/office/drawing/2014/main" id="{2E40E70B-D1B4-4A58-B9B5-D0A9F39D0DD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A99DD0D2-BACB-4ED0-9213-FC9B30C0B09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9AC13D-D462-455C-A8A4-B01D924C7252}" type="datetimeFigureOut">
              <a:rPr lang="fr-FR" smtClean="0"/>
              <a:t>18/05/2019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187BA780-2809-409E-BE14-0F22D1E7518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0388DD0B-CD66-4969-A38C-A55AF6F7AB4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79FB26-0C37-4F20-B484-D4D7BE0B9AA8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9360903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18BB2622-6B9C-4E0F-B705-7AA49572B52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pour une image  2">
            <a:extLst>
              <a:ext uri="{FF2B5EF4-FFF2-40B4-BE49-F238E27FC236}">
                <a16:creationId xmlns:a16="http://schemas.microsoft.com/office/drawing/2014/main" id="{FA32A2F3-6BC4-43D2-A117-703CCEFF8635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>
            <a:extLst>
              <a:ext uri="{FF2B5EF4-FFF2-40B4-BE49-F238E27FC236}">
                <a16:creationId xmlns:a16="http://schemas.microsoft.com/office/drawing/2014/main" id="{B1D61D3B-5254-4345-8EA7-295B38B7996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6919B102-C8F1-4DE5-81CF-6D769A676DB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9AC13D-D462-455C-A8A4-B01D924C7252}" type="datetimeFigureOut">
              <a:rPr lang="fr-FR" smtClean="0"/>
              <a:t>18/05/2019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03E35610-EDBF-4A1B-9486-DD232658510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14A807BA-A163-4394-BEE3-00D2F9ED426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79FB26-0C37-4F20-B484-D4D7BE0B9AA8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27489453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>
            <a:extLst>
              <a:ext uri="{FF2B5EF4-FFF2-40B4-BE49-F238E27FC236}">
                <a16:creationId xmlns:a16="http://schemas.microsoft.com/office/drawing/2014/main" id="{C01975DF-6D2F-4DA5-B5BA-A1B5F43AAFE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17720D05-65AB-461A-A544-E6C6FDA27E3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63C0A11A-C570-468E-AA07-EF69B11F8739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B9AC13D-D462-455C-A8A4-B01D924C7252}" type="datetimeFigureOut">
              <a:rPr lang="fr-FR" smtClean="0"/>
              <a:t>18/05/2019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5B3262D0-5FA9-47F9-9E48-EB94EDB13BEA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3B024751-7490-42DB-80E5-067EE57A2664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A79FB26-0C37-4F20-B484-D4D7BE0B9AA8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51569399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" name="ZoneTexte 14">
            <a:extLst>
              <a:ext uri="{FF2B5EF4-FFF2-40B4-BE49-F238E27FC236}">
                <a16:creationId xmlns:a16="http://schemas.microsoft.com/office/drawing/2014/main" id="{03F58360-3607-4642-968C-CCB04318E9E1}"/>
              </a:ext>
            </a:extLst>
          </p:cNvPr>
          <p:cNvSpPr txBox="1"/>
          <p:nvPr/>
        </p:nvSpPr>
        <p:spPr>
          <a:xfrm>
            <a:off x="717300" y="3741787"/>
            <a:ext cx="10859003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1. </a:t>
            </a:r>
            <a:r>
              <a:rPr lang="fr-F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LC-MS </a:t>
            </a:r>
            <a:r>
              <a:rPr lang="fr-FR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hromatogram</a:t>
            </a:r>
            <a:r>
              <a:rPr lang="fr-F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QC </a:t>
            </a:r>
            <a:r>
              <a:rPr lang="fr-FR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ample</a:t>
            </a:r>
            <a:r>
              <a:rPr lang="fr-F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in </a:t>
            </a:r>
            <a:r>
              <a:rPr lang="fr-FR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negative</a:t>
            </a:r>
            <a:r>
              <a:rPr lang="fr-F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d positive ESI modes </a:t>
            </a:r>
            <a:r>
              <a:rPr lang="fr-FR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using</a:t>
            </a:r>
            <a:r>
              <a:rPr lang="fr-F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C18 or HILIC </a:t>
            </a:r>
            <a:r>
              <a:rPr lang="fr-FR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eparation</a:t>
            </a:r>
            <a:r>
              <a:rPr lang="fr-F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fr-FR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olumns</a:t>
            </a:r>
            <a:r>
              <a:rPr lang="fr-F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For the C18 </a:t>
            </a:r>
            <a:r>
              <a:rPr lang="fr-FR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olumn</a:t>
            </a:r>
            <a:r>
              <a:rPr lang="fr-F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the </a:t>
            </a:r>
            <a:r>
              <a:rPr lang="fr-FR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Venn</a:t>
            </a:r>
            <a:r>
              <a:rPr lang="fr-F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Diagram displays the </a:t>
            </a:r>
            <a:r>
              <a:rPr lang="fr-FR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number</a:t>
            </a:r>
            <a:r>
              <a:rPr lang="fr-F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of compounds </a:t>
            </a:r>
            <a:r>
              <a:rPr lang="fr-FR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detected</a:t>
            </a:r>
            <a:r>
              <a:rPr lang="fr-F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in </a:t>
            </a:r>
            <a:r>
              <a:rPr lang="fr-FR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each</a:t>
            </a:r>
            <a:r>
              <a:rPr lang="fr-F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fr-FR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ionization</a:t>
            </a:r>
            <a:r>
              <a:rPr lang="fr-F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mode. The main classes of compounds </a:t>
            </a:r>
            <a:r>
              <a:rPr lang="fr-FR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detected</a:t>
            </a:r>
            <a:r>
              <a:rPr lang="fr-F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re </a:t>
            </a:r>
            <a:r>
              <a:rPr lang="fr-FR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indicated</a:t>
            </a:r>
            <a:r>
              <a:rPr lang="fr-F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by the double </a:t>
            </a:r>
            <a:r>
              <a:rPr lang="fr-FR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rrows</a:t>
            </a:r>
            <a:r>
              <a:rPr lang="fr-F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For the HILIC </a:t>
            </a:r>
            <a:r>
              <a:rPr lang="fr-FR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olumn</a:t>
            </a:r>
            <a:r>
              <a:rPr lang="fr-F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</a:t>
            </a:r>
            <a:r>
              <a:rPr lang="fr-FR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only</a:t>
            </a:r>
            <a:r>
              <a:rPr lang="fr-F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the </a:t>
            </a:r>
            <a:r>
              <a:rPr lang="fr-FR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lower</a:t>
            </a:r>
            <a:r>
              <a:rPr lang="fr-F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phase </a:t>
            </a:r>
            <a:r>
              <a:rPr lang="fr-FR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ontaining</a:t>
            </a:r>
            <a:r>
              <a:rPr lang="fr-F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polar compounds </a:t>
            </a:r>
            <a:r>
              <a:rPr lang="fr-FR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was</a:t>
            </a:r>
            <a:r>
              <a:rPr lang="fr-F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fr-FR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rofiled</a:t>
            </a:r>
            <a:r>
              <a:rPr lang="fr-F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FA: free </a:t>
            </a:r>
            <a:r>
              <a:rPr lang="fr-FR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fatty</a:t>
            </a:r>
            <a:r>
              <a:rPr lang="fr-F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fr-FR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cids</a:t>
            </a:r>
            <a:r>
              <a:rPr lang="fr-F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; FA-OH: </a:t>
            </a:r>
            <a:r>
              <a:rPr lang="fr-FR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hydroxylated</a:t>
            </a:r>
            <a:r>
              <a:rPr lang="fr-F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/oxo-</a:t>
            </a:r>
            <a:r>
              <a:rPr lang="fr-FR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fatty</a:t>
            </a:r>
            <a:r>
              <a:rPr lang="fr-F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fr-FR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cids</a:t>
            </a:r>
            <a:r>
              <a:rPr lang="fr-F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; MG: </a:t>
            </a:r>
            <a:r>
              <a:rPr lang="fr-FR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onoglycerides</a:t>
            </a:r>
            <a:r>
              <a:rPr lang="fr-F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; DG: </a:t>
            </a:r>
            <a:r>
              <a:rPr lang="fr-FR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Diglycerides</a:t>
            </a:r>
            <a:r>
              <a:rPr lang="fr-F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; TG: </a:t>
            </a:r>
            <a:r>
              <a:rPr lang="fr-FR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riglycerides</a:t>
            </a:r>
            <a:r>
              <a:rPr lang="fr-F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; PG: </a:t>
            </a:r>
            <a:r>
              <a:rPr lang="fr-FR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hosphorylated</a:t>
            </a:r>
            <a:r>
              <a:rPr lang="fr-F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fr-FR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glycerides</a:t>
            </a:r>
            <a:r>
              <a:rPr lang="fr-F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</a:p>
        </p:txBody>
      </p:sp>
      <p:grpSp>
        <p:nvGrpSpPr>
          <p:cNvPr id="2" name="Groupe 1">
            <a:extLst>
              <a:ext uri="{FF2B5EF4-FFF2-40B4-BE49-F238E27FC236}">
                <a16:creationId xmlns:a16="http://schemas.microsoft.com/office/drawing/2014/main" id="{BF2254F5-BC57-4465-BF40-1ED5AD0D3E32}"/>
              </a:ext>
            </a:extLst>
          </p:cNvPr>
          <p:cNvGrpSpPr/>
          <p:nvPr/>
        </p:nvGrpSpPr>
        <p:grpSpPr>
          <a:xfrm>
            <a:off x="202962" y="192024"/>
            <a:ext cx="11683271" cy="3453200"/>
            <a:chOff x="202962" y="192024"/>
            <a:chExt cx="11683271" cy="3453200"/>
          </a:xfrm>
        </p:grpSpPr>
        <p:pic>
          <p:nvPicPr>
            <p:cNvPr id="4" name="Image 3">
              <a:extLst>
                <a:ext uri="{FF2B5EF4-FFF2-40B4-BE49-F238E27FC236}">
                  <a16:creationId xmlns:a16="http://schemas.microsoft.com/office/drawing/2014/main" id="{82807201-06B1-4C47-B572-72CB8F8CA32C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/>
            <a:srcRect t="2800" b="2533"/>
            <a:stretch/>
          </p:blipFill>
          <p:spPr>
            <a:xfrm>
              <a:off x="202962" y="192024"/>
              <a:ext cx="5876437" cy="3236976"/>
            </a:xfrm>
            <a:prstGeom prst="rect">
              <a:avLst/>
            </a:prstGeom>
          </p:spPr>
        </p:pic>
        <p:sp>
          <p:nvSpPr>
            <p:cNvPr id="5" name="Flèche : double flèche horizontale 4">
              <a:extLst>
                <a:ext uri="{FF2B5EF4-FFF2-40B4-BE49-F238E27FC236}">
                  <a16:creationId xmlns:a16="http://schemas.microsoft.com/office/drawing/2014/main" id="{D5582CD9-625A-4159-8649-485FCEA12991}"/>
                </a:ext>
              </a:extLst>
            </p:cNvPr>
            <p:cNvSpPr/>
            <p:nvPr/>
          </p:nvSpPr>
          <p:spPr>
            <a:xfrm>
              <a:off x="466344" y="3374513"/>
              <a:ext cx="3172968" cy="252000"/>
            </a:xfrm>
            <a:prstGeom prst="leftRightArrow">
              <a:avLst/>
            </a:prstGeom>
          </p:spPr>
          <p:style>
            <a:lnRef idx="2">
              <a:schemeClr val="accent4">
                <a:shade val="50000"/>
              </a:schemeClr>
            </a:lnRef>
            <a:fillRef idx="1">
              <a:schemeClr val="accent4"/>
            </a:fillRef>
            <a:effectRef idx="0">
              <a:schemeClr val="accent4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6" name="Flèche : double flèche horizontale 5">
              <a:extLst>
                <a:ext uri="{FF2B5EF4-FFF2-40B4-BE49-F238E27FC236}">
                  <a16:creationId xmlns:a16="http://schemas.microsoft.com/office/drawing/2014/main" id="{BF931518-FDF5-4D6F-9961-64249D734D26}"/>
                </a:ext>
              </a:extLst>
            </p:cNvPr>
            <p:cNvSpPr/>
            <p:nvPr/>
          </p:nvSpPr>
          <p:spPr>
            <a:xfrm>
              <a:off x="3639312" y="3374513"/>
              <a:ext cx="2020824" cy="252000"/>
            </a:xfrm>
            <a:prstGeom prst="leftRightArrow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fr-FR" sz="1400" b="1" dirty="0">
                  <a:solidFill>
                    <a:schemeClr val="tx1"/>
                  </a:solidFill>
                </a:rPr>
                <a:t>MG-DG-TG</a:t>
              </a:r>
            </a:p>
          </p:txBody>
        </p:sp>
        <p:pic>
          <p:nvPicPr>
            <p:cNvPr id="7" name="Image 6">
              <a:extLst>
                <a:ext uri="{FF2B5EF4-FFF2-40B4-BE49-F238E27FC236}">
                  <a16:creationId xmlns:a16="http://schemas.microsoft.com/office/drawing/2014/main" id="{089FA1DF-F1B7-4B32-86BD-4068C73FA82B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/>
            <a:srcRect t="2800" b="2800"/>
            <a:stretch/>
          </p:blipFill>
          <p:spPr>
            <a:xfrm>
              <a:off x="6342781" y="192024"/>
              <a:ext cx="5543452" cy="3236976"/>
            </a:xfrm>
            <a:prstGeom prst="rect">
              <a:avLst/>
            </a:prstGeom>
          </p:spPr>
        </p:pic>
        <p:sp>
          <p:nvSpPr>
            <p:cNvPr id="8" name="ZoneTexte 7">
              <a:extLst>
                <a:ext uri="{FF2B5EF4-FFF2-40B4-BE49-F238E27FC236}">
                  <a16:creationId xmlns:a16="http://schemas.microsoft.com/office/drawing/2014/main" id="{F7D490C2-7BD6-4000-9017-BBA85480568D}"/>
                </a:ext>
              </a:extLst>
            </p:cNvPr>
            <p:cNvSpPr txBox="1"/>
            <p:nvPr/>
          </p:nvSpPr>
          <p:spPr>
            <a:xfrm>
              <a:off x="518774" y="271540"/>
              <a:ext cx="1776577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200" b="1" dirty="0" err="1">
                  <a:solidFill>
                    <a:srgbClr val="FF0000"/>
                  </a:solidFill>
                </a:rPr>
                <a:t>Upper</a:t>
              </a:r>
              <a:r>
                <a:rPr lang="fr-FR" sz="1200" b="1" dirty="0">
                  <a:solidFill>
                    <a:srgbClr val="FF0000"/>
                  </a:solidFill>
                </a:rPr>
                <a:t> phase-C18 ESI </a:t>
              </a:r>
              <a:r>
                <a:rPr lang="fr-FR" sz="1200" b="1" dirty="0" err="1">
                  <a:solidFill>
                    <a:srgbClr val="FF0000"/>
                  </a:solidFill>
                </a:rPr>
                <a:t>neg</a:t>
              </a:r>
              <a:endParaRPr lang="fr-FR" sz="1200" b="1" dirty="0">
                <a:solidFill>
                  <a:srgbClr val="FF0000"/>
                </a:solidFill>
              </a:endParaRPr>
            </a:p>
          </p:txBody>
        </p:sp>
        <p:sp>
          <p:nvSpPr>
            <p:cNvPr id="9" name="ZoneTexte 8">
              <a:extLst>
                <a:ext uri="{FF2B5EF4-FFF2-40B4-BE49-F238E27FC236}">
                  <a16:creationId xmlns:a16="http://schemas.microsoft.com/office/drawing/2014/main" id="{88A4F226-EE2A-4495-86D2-EBB13A73FF54}"/>
                </a:ext>
              </a:extLst>
            </p:cNvPr>
            <p:cNvSpPr txBox="1"/>
            <p:nvPr/>
          </p:nvSpPr>
          <p:spPr>
            <a:xfrm>
              <a:off x="3639312" y="271539"/>
              <a:ext cx="176542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200" b="1" dirty="0" err="1">
                  <a:solidFill>
                    <a:schemeClr val="accent1"/>
                  </a:solidFill>
                </a:rPr>
                <a:t>Lower</a:t>
              </a:r>
              <a:r>
                <a:rPr lang="fr-FR" sz="1200" b="1" dirty="0">
                  <a:solidFill>
                    <a:schemeClr val="accent1"/>
                  </a:solidFill>
                </a:rPr>
                <a:t> phase-C18 ESI pos</a:t>
              </a:r>
            </a:p>
          </p:txBody>
        </p:sp>
        <p:sp>
          <p:nvSpPr>
            <p:cNvPr id="10" name="ZoneTexte 9">
              <a:extLst>
                <a:ext uri="{FF2B5EF4-FFF2-40B4-BE49-F238E27FC236}">
                  <a16:creationId xmlns:a16="http://schemas.microsoft.com/office/drawing/2014/main" id="{9C89B7AA-06BC-40E7-AC67-320F3BFBD70C}"/>
                </a:ext>
              </a:extLst>
            </p:cNvPr>
            <p:cNvSpPr txBox="1"/>
            <p:nvPr/>
          </p:nvSpPr>
          <p:spPr>
            <a:xfrm>
              <a:off x="7136692" y="271539"/>
              <a:ext cx="180389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200" b="1" dirty="0" err="1">
                  <a:solidFill>
                    <a:schemeClr val="accent1"/>
                  </a:solidFill>
                </a:rPr>
                <a:t>Lower</a:t>
              </a:r>
              <a:r>
                <a:rPr lang="fr-FR" sz="1200" b="1" dirty="0">
                  <a:solidFill>
                    <a:schemeClr val="accent1"/>
                  </a:solidFill>
                </a:rPr>
                <a:t> phase-</a:t>
              </a:r>
              <a:r>
                <a:rPr lang="fr-FR" sz="1200" b="1" dirty="0" err="1">
                  <a:solidFill>
                    <a:schemeClr val="accent1"/>
                  </a:solidFill>
                </a:rPr>
                <a:t>Hilic</a:t>
              </a:r>
              <a:r>
                <a:rPr lang="fr-FR" sz="1200" b="1" dirty="0">
                  <a:solidFill>
                    <a:schemeClr val="accent1"/>
                  </a:solidFill>
                </a:rPr>
                <a:t> ESI pos</a:t>
              </a:r>
            </a:p>
          </p:txBody>
        </p:sp>
        <p:sp>
          <p:nvSpPr>
            <p:cNvPr id="11" name="ZoneTexte 10">
              <a:extLst>
                <a:ext uri="{FF2B5EF4-FFF2-40B4-BE49-F238E27FC236}">
                  <a16:creationId xmlns:a16="http://schemas.microsoft.com/office/drawing/2014/main" id="{AF4F7FFF-324B-4247-9C28-C904BF887CE9}"/>
                </a:ext>
              </a:extLst>
            </p:cNvPr>
            <p:cNvSpPr txBox="1"/>
            <p:nvPr/>
          </p:nvSpPr>
          <p:spPr>
            <a:xfrm>
              <a:off x="933501" y="3368225"/>
              <a:ext cx="58791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200" b="1" dirty="0"/>
                <a:t>FA-OH</a:t>
              </a:r>
            </a:p>
          </p:txBody>
        </p:sp>
        <p:sp>
          <p:nvSpPr>
            <p:cNvPr id="12" name="ZoneTexte 11">
              <a:extLst>
                <a:ext uri="{FF2B5EF4-FFF2-40B4-BE49-F238E27FC236}">
                  <a16:creationId xmlns:a16="http://schemas.microsoft.com/office/drawing/2014/main" id="{3C450CEC-17E8-4E18-9EA9-C2DC39E2D78D}"/>
                </a:ext>
              </a:extLst>
            </p:cNvPr>
            <p:cNvSpPr txBox="1"/>
            <p:nvPr/>
          </p:nvSpPr>
          <p:spPr>
            <a:xfrm>
              <a:off x="2332977" y="3368224"/>
              <a:ext cx="33945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200" b="1" dirty="0"/>
                <a:t>FA</a:t>
              </a:r>
            </a:p>
          </p:txBody>
        </p:sp>
        <p:sp>
          <p:nvSpPr>
            <p:cNvPr id="14" name="Flèche : double flèche horizontale 13">
              <a:extLst>
                <a:ext uri="{FF2B5EF4-FFF2-40B4-BE49-F238E27FC236}">
                  <a16:creationId xmlns:a16="http://schemas.microsoft.com/office/drawing/2014/main" id="{62FB1BF0-1A20-4AF3-B437-23B199D3AF82}"/>
                </a:ext>
              </a:extLst>
            </p:cNvPr>
            <p:cNvSpPr/>
            <p:nvPr/>
          </p:nvSpPr>
          <p:spPr>
            <a:xfrm>
              <a:off x="6823620" y="3385296"/>
              <a:ext cx="4752683" cy="252000"/>
            </a:xfrm>
            <a:prstGeom prst="leftRightArrow">
              <a:avLst/>
            </a:prstGeom>
          </p:spPr>
          <p:style>
            <a:lnRef idx="2">
              <a:schemeClr val="accent6">
                <a:shade val="50000"/>
              </a:schemeClr>
            </a:lnRef>
            <a:fillRef idx="1">
              <a:schemeClr val="accent6"/>
            </a:fillRef>
            <a:effectRef idx="0">
              <a:schemeClr val="accent6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fr-FR" sz="1400" b="1" dirty="0">
                  <a:solidFill>
                    <a:schemeClr val="tx1"/>
                  </a:solidFill>
                </a:rPr>
                <a:t>PG-</a:t>
              </a:r>
              <a:r>
                <a:rPr lang="fr-FR" sz="1400" b="1" dirty="0" err="1">
                  <a:solidFill>
                    <a:schemeClr val="tx1"/>
                  </a:solidFill>
                </a:rPr>
                <a:t>Flavonoides</a:t>
              </a:r>
              <a:r>
                <a:rPr lang="fr-FR" sz="1400" b="1" dirty="0">
                  <a:solidFill>
                    <a:schemeClr val="tx1"/>
                  </a:solidFill>
                </a:rPr>
                <a:t>…</a:t>
              </a:r>
            </a:p>
          </p:txBody>
        </p:sp>
        <p:sp>
          <p:nvSpPr>
            <p:cNvPr id="24" name="Ellipse 23">
              <a:extLst>
                <a:ext uri="{FF2B5EF4-FFF2-40B4-BE49-F238E27FC236}">
                  <a16:creationId xmlns:a16="http://schemas.microsoft.com/office/drawing/2014/main" id="{D4BE8F2E-3571-457E-81AC-34322A275089}"/>
                </a:ext>
              </a:extLst>
            </p:cNvPr>
            <p:cNvSpPr/>
            <p:nvPr/>
          </p:nvSpPr>
          <p:spPr>
            <a:xfrm>
              <a:off x="1738617" y="690183"/>
              <a:ext cx="1188720" cy="1225296"/>
            </a:xfrm>
            <a:prstGeom prst="ellipse">
              <a:avLst/>
            </a:prstGeom>
            <a:solidFill>
              <a:srgbClr val="C00000">
                <a:alpha val="36000"/>
              </a:srgb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fr-FR" dirty="0"/>
                <a:t>75</a:t>
              </a:r>
            </a:p>
          </p:txBody>
        </p:sp>
        <p:sp>
          <p:nvSpPr>
            <p:cNvPr id="25" name="Ellipse 24">
              <a:extLst>
                <a:ext uri="{FF2B5EF4-FFF2-40B4-BE49-F238E27FC236}">
                  <a16:creationId xmlns:a16="http://schemas.microsoft.com/office/drawing/2014/main" id="{4FDE0308-C090-4084-B9F2-A21BBB117331}"/>
                </a:ext>
              </a:extLst>
            </p:cNvPr>
            <p:cNvSpPr/>
            <p:nvPr/>
          </p:nvSpPr>
          <p:spPr>
            <a:xfrm>
              <a:off x="2596359" y="690183"/>
              <a:ext cx="1188720" cy="1225296"/>
            </a:xfrm>
            <a:prstGeom prst="ellipse">
              <a:avLst/>
            </a:prstGeom>
            <a:solidFill>
              <a:schemeClr val="accent1">
                <a:alpha val="36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fr-FR" dirty="0"/>
                <a:t>76</a:t>
              </a:r>
            </a:p>
          </p:txBody>
        </p:sp>
        <p:sp>
          <p:nvSpPr>
            <p:cNvPr id="26" name="ZoneTexte 25">
              <a:extLst>
                <a:ext uri="{FF2B5EF4-FFF2-40B4-BE49-F238E27FC236}">
                  <a16:creationId xmlns:a16="http://schemas.microsoft.com/office/drawing/2014/main" id="{64CC9394-687A-4CA0-A525-1B99C7E9C735}"/>
                </a:ext>
              </a:extLst>
            </p:cNvPr>
            <p:cNvSpPr txBox="1"/>
            <p:nvPr/>
          </p:nvSpPr>
          <p:spPr>
            <a:xfrm>
              <a:off x="2541684" y="1209123"/>
              <a:ext cx="41870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dirty="0"/>
                <a:t>10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2938022709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1</TotalTime>
  <Words>118</Words>
  <Application>Microsoft Office PowerPoint</Application>
  <PresentationFormat>Grand écran</PresentationFormat>
  <Paragraphs>11</Paragraphs>
  <Slides>1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4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Thème Office</vt:lpstr>
      <vt:lpstr>Présentation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Guikal Martal</dc:creator>
  <cp:lastModifiedBy>Guikal Martal</cp:lastModifiedBy>
  <cp:revision>151</cp:revision>
  <cp:lastPrinted>2018-12-03T12:43:33Z</cp:lastPrinted>
  <dcterms:created xsi:type="dcterms:W3CDTF">2018-11-25T21:30:07Z</dcterms:created>
  <dcterms:modified xsi:type="dcterms:W3CDTF">2019-05-18T18:12:32Z</dcterms:modified>
</cp:coreProperties>
</file>